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8" r:id="rId2"/>
    <p:sldId id="279" r:id="rId3"/>
    <p:sldId id="280" r:id="rId4"/>
  </p:sldIdLst>
  <p:sldSz cx="9144000" cy="8999538"/>
  <p:notesSz cx="6858000" cy="9144000"/>
  <p:custDataLst>
    <p:tags r:id="rId5"/>
  </p:custDataLst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93">
          <p15:clr>
            <a:srgbClr val="A4A3A4"/>
          </p15:clr>
        </p15:guide>
        <p15:guide id="2" pos="27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 autoAdjust="0"/>
    <p:restoredTop sz="94531" autoAdjust="0"/>
  </p:normalViewPr>
  <p:slideViewPr>
    <p:cSldViewPr>
      <p:cViewPr varScale="1">
        <p:scale>
          <a:sx n="79" d="100"/>
          <a:sy n="79" d="100"/>
        </p:scale>
        <p:origin x="1968" y="216"/>
      </p:cViewPr>
      <p:guideLst>
        <p:guide orient="horz" pos="2893"/>
        <p:guide pos="27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72842"/>
            <a:ext cx="7772400" cy="313317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726842"/>
            <a:ext cx="6858000" cy="217280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0A7251-0E8C-75D7-0353-3A2F74D31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6CF470-4D43-1F79-795B-6A2B3FD99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120218-BA73-604B-EDFE-A3CAEB0BB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275979-A780-BF4B-87EE-C926F08DB53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3267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243276-881E-0B80-D870-DB0252C3C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E6CB59-6118-B4A1-7D80-E10993134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C88CBD-738C-15A5-5063-CF2D6F8DC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3BD59B-5715-6B46-A0E3-C345E77676C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7984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79142"/>
            <a:ext cx="1971675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79142"/>
            <a:ext cx="5800725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9BE029-CC85-506E-8936-671CF04E0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D14B6D-86CD-1870-509D-25C30B3C0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35B758-E514-0902-0C61-5D96EBD69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2FDED-BE2F-8242-BE6C-B9E75758254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4036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E5CCA6-0F90-6D74-8FE3-AED98FA4D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70DB78-723B-3A6A-E4D8-39C6D828A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8F0A56-75FE-DF16-4017-3A500CDB6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B767F0-4F46-2941-AC2C-5BF24C00086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9537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243638"/>
            <a:ext cx="7886700" cy="374355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022610"/>
            <a:ext cx="7886700" cy="196864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CC104F-CCB1-4AEA-B91C-E69C5A027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BB5CB5-264B-1748-DCE2-07028E803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037476-E3BA-6820-11DC-1674113C3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EE2117-AD10-F549-B5F8-9A707651314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9906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C253E6B-0AFB-3486-57A5-13BB8FEFD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A1A1C0BF-7CE2-3E22-EBEC-3B79B0F1B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6334E8A6-15C6-3E08-B955-E90BA7D9F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6BDDE9-7361-C244-BB9A-06F4B2463FF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6778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79144"/>
            <a:ext cx="78867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206137"/>
            <a:ext cx="3868340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287331"/>
            <a:ext cx="3868340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206137"/>
            <a:ext cx="3887391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287331"/>
            <a:ext cx="3887391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4D93B79E-D0AF-06F3-E1BD-0DC3262BD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BCD4A294-5482-296C-E93E-7E724735B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781FD0A-D2AA-7275-C6DE-3C5DCDCFE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B32F14-F635-D843-ACA2-475B0042AAE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541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CBD69474-CF39-2D90-C9D8-288366AC0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2045D43B-3250-0BBD-5EF1-93F7B19EA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99BFCFFA-69CF-CF12-14A5-7156E3C6D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EA21DB-0B3D-2340-BD78-EB1BE476F81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052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C0DDF276-06D4-F35D-B324-4578B525A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B757285B-882C-0567-C71C-046EEC1E0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F9E9B7DB-EBFD-9788-7F94-8DDA27825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432B21-E99C-B84E-937F-3C7D3974BE3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2118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295769"/>
            <a:ext cx="4629150" cy="639550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6492B0A-A629-BA44-944F-3F891FB0A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B5676932-1C21-E322-4962-6CB788E01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F152613-F9E7-C4DB-EE7E-E3FEAC3BC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E185A7-3A12-FF40-AE2D-E1BF6D1B147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940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295769"/>
            <a:ext cx="4629150" cy="639550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CN" altLang="en-US" noProof="0"/>
              <a:t>单击图标添加图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0D3C6D5-E7BA-A6B8-ADBE-59D4120F0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1FAABF3-453E-8437-8E5F-69250F4DF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A67B03D-42BA-B828-B10D-FF1318623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04E825-9D6D-084A-8290-92B0A2A4F25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587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F5C1C96E-5645-8543-8E0B-8660487F4DC6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479425"/>
            <a:ext cx="7886700" cy="173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92261364-707C-5993-F5CF-BFD8EAD09708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28650" y="2395538"/>
            <a:ext cx="7886700" cy="5710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8EA03B-D128-37E9-171C-F17FCEC459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CC4A5B-388E-93FD-E232-209D64D365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8340725"/>
            <a:ext cx="30861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26C2FB-9C85-FE99-C136-3EC1A7F8C6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A6E21FB-F040-4E4B-82EE-26C944D7E96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5" name="图片 3" descr="nlrp3-">
            <a:extLst>
              <a:ext uri="{FF2B5EF4-FFF2-40B4-BE49-F238E27FC236}">
                <a16:creationId xmlns:a16="http://schemas.microsoft.com/office/drawing/2014/main" id="{0813C053-EA11-6F74-62EA-C61FE0E96D8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39" b="11890"/>
          <a:stretch>
            <a:fillRect/>
          </a:stretch>
        </p:blipFill>
        <p:spPr bwMode="auto">
          <a:xfrm>
            <a:off x="2051050" y="2700338"/>
            <a:ext cx="5984875" cy="2952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866" name="文本框 30">
            <a:extLst>
              <a:ext uri="{FF2B5EF4-FFF2-40B4-BE49-F238E27FC236}">
                <a16:creationId xmlns:a16="http://schemas.microsoft.com/office/drawing/2014/main" id="{02CEF5C1-1FF4-0E48-422F-A2B5BB3525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6513" y="1092200"/>
            <a:ext cx="3968751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cGAMP-RU521</a:t>
            </a:r>
            <a:r>
              <a:rPr lang="zh-CN" altLang="en-US" sz="1800"/>
              <a:t>细胞</a:t>
            </a:r>
            <a:r>
              <a:rPr lang="en-US" altLang="zh-CN" sz="1800"/>
              <a:t>NLRP3</a:t>
            </a:r>
            <a:r>
              <a:rPr lang="en-US" altLang="zh-CN" sz="1800">
                <a:sym typeface="宋体" panose="02010600030101010101" pitchFamily="2" charset="-122"/>
              </a:rPr>
              <a:t>,</a:t>
            </a:r>
            <a:r>
              <a:rPr lang="en-US" altLang="zh-CN" sz="1800"/>
              <a:t>N=3</a:t>
            </a:r>
          </a:p>
        </p:txBody>
      </p:sp>
      <p:sp>
        <p:nvSpPr>
          <p:cNvPr id="36867" name="文本框 18">
            <a:extLst>
              <a:ext uri="{FF2B5EF4-FFF2-40B4-BE49-F238E27FC236}">
                <a16:creationId xmlns:a16="http://schemas.microsoft.com/office/drawing/2014/main" id="{C11AA573-85BF-A14C-ACD2-0F2665FE38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25" y="2974975"/>
            <a:ext cx="8826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6868" name="文本框 19">
            <a:extLst>
              <a:ext uri="{FF2B5EF4-FFF2-40B4-BE49-F238E27FC236}">
                <a16:creationId xmlns:a16="http://schemas.microsoft.com/office/drawing/2014/main" id="{6A36BB96-E31A-2B06-FA08-0601BD04C5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41450" y="3100388"/>
            <a:ext cx="8810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6869" name="文本框 20">
            <a:extLst>
              <a:ext uri="{FF2B5EF4-FFF2-40B4-BE49-F238E27FC236}">
                <a16:creationId xmlns:a16="http://schemas.microsoft.com/office/drawing/2014/main" id="{E03B6A78-4AC3-F67C-15A8-9A2B4B7D25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41450" y="3244850"/>
            <a:ext cx="8810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6870" name="文本框 21">
            <a:extLst>
              <a:ext uri="{FF2B5EF4-FFF2-40B4-BE49-F238E27FC236}">
                <a16:creationId xmlns:a16="http://schemas.microsoft.com/office/drawing/2014/main" id="{9F09B632-6AA3-5540-08D2-BD6C3C530C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14475" y="3503613"/>
            <a:ext cx="7350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6871" name="文本框 22">
            <a:extLst>
              <a:ext uri="{FF2B5EF4-FFF2-40B4-BE49-F238E27FC236}">
                <a16:creationId xmlns:a16="http://schemas.microsoft.com/office/drawing/2014/main" id="{79B4A68B-D08A-3BCA-B82A-259353BB29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3763963"/>
            <a:ext cx="8112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6872" name="文本框 23">
            <a:extLst>
              <a:ext uri="{FF2B5EF4-FFF2-40B4-BE49-F238E27FC236}">
                <a16:creationId xmlns:a16="http://schemas.microsoft.com/office/drawing/2014/main" id="{DA2B46E2-E5A0-25AF-A2DA-E87D4EF0D6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4189413"/>
            <a:ext cx="7366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6873" name="文本框 24">
            <a:extLst>
              <a:ext uri="{FF2B5EF4-FFF2-40B4-BE49-F238E27FC236}">
                <a16:creationId xmlns:a16="http://schemas.microsoft.com/office/drawing/2014/main" id="{0F9651D9-5C75-105C-B0CC-D8DE5298DA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14475" y="4533900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6874" name="文本框 25">
            <a:extLst>
              <a:ext uri="{FF2B5EF4-FFF2-40B4-BE49-F238E27FC236}">
                <a16:creationId xmlns:a16="http://schemas.microsoft.com/office/drawing/2014/main" id="{0EE46744-84A2-2072-BBFD-12743C730F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14475" y="4840288"/>
            <a:ext cx="7350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6875" name="文本框 26">
            <a:extLst>
              <a:ext uri="{FF2B5EF4-FFF2-40B4-BE49-F238E27FC236}">
                <a16:creationId xmlns:a16="http://schemas.microsoft.com/office/drawing/2014/main" id="{B1A9694D-83D6-536A-CABD-E82FECA148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14475" y="5275263"/>
            <a:ext cx="7350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5A3E3497-7AE2-4B33-EC1A-4BD02AAB402B}"/>
              </a:ext>
            </a:extLst>
          </p:cNvPr>
          <p:cNvSpPr/>
          <p:nvPr/>
        </p:nvSpPr>
        <p:spPr>
          <a:xfrm>
            <a:off x="2779713" y="4427538"/>
            <a:ext cx="4603750" cy="33337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D1405E66-016F-6A5F-B287-C89F4A1DE494}"/>
              </a:ext>
            </a:extLst>
          </p:cNvPr>
          <p:cNvSpPr/>
          <p:nvPr/>
        </p:nvSpPr>
        <p:spPr>
          <a:xfrm>
            <a:off x="2771775" y="3275013"/>
            <a:ext cx="4483100" cy="31591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6878" name="文本框 56">
            <a:extLst>
              <a:ext uri="{FF2B5EF4-FFF2-40B4-BE49-F238E27FC236}">
                <a16:creationId xmlns:a16="http://schemas.microsoft.com/office/drawing/2014/main" id="{63093AD7-DE1D-A2D8-0089-CA77760F2F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13513" y="2979738"/>
            <a:ext cx="130651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  <a:sym typeface="宋体" panose="02010600030101010101" pitchFamily="2" charset="-122"/>
              </a:rPr>
              <a:t>NLRP3</a:t>
            </a: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6879" name="文本框 56">
            <a:extLst>
              <a:ext uri="{FF2B5EF4-FFF2-40B4-BE49-F238E27FC236}">
                <a16:creationId xmlns:a16="http://schemas.microsoft.com/office/drawing/2014/main" id="{59F39083-90CD-8EE6-4588-A7C4DBDDAC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84950" y="4799013"/>
            <a:ext cx="106838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36880" name="文本框 3">
            <a:extLst>
              <a:ext uri="{FF2B5EF4-FFF2-40B4-BE49-F238E27FC236}">
                <a16:creationId xmlns:a16="http://schemas.microsoft.com/office/drawing/2014/main" id="{67FBF6A6-434C-13D9-38D7-AADA349A378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767806" y="2399507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</a:p>
        </p:txBody>
      </p:sp>
      <p:sp>
        <p:nvSpPr>
          <p:cNvPr id="36881" name="文本框 4">
            <a:extLst>
              <a:ext uri="{FF2B5EF4-FFF2-40B4-BE49-F238E27FC236}">
                <a16:creationId xmlns:a16="http://schemas.microsoft.com/office/drawing/2014/main" id="{B7956965-DF9C-C533-4991-0EDC12CE29B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164681" y="2321719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6882" name="文本框 5">
            <a:extLst>
              <a:ext uri="{FF2B5EF4-FFF2-40B4-BE49-F238E27FC236}">
                <a16:creationId xmlns:a16="http://schemas.microsoft.com/office/drawing/2014/main" id="{76B31AE1-938F-3260-D2E4-9328BCB9DDE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04406" y="2399507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</a:p>
        </p:txBody>
      </p:sp>
      <p:sp>
        <p:nvSpPr>
          <p:cNvPr id="36883" name="文本框 6">
            <a:extLst>
              <a:ext uri="{FF2B5EF4-FFF2-40B4-BE49-F238E27FC236}">
                <a16:creationId xmlns:a16="http://schemas.microsoft.com/office/drawing/2014/main" id="{F793D99C-43F3-6006-23E1-956B99E16B9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741737" y="2227263"/>
            <a:ext cx="9429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GAMP</a:t>
            </a:r>
            <a:endParaRPr lang="en-US" altLang="zh-CN" sz="1000" baseline="-25000">
              <a:latin typeface="Times New Roman" panose="02020603050405020304" pitchFamily="18" charset="0"/>
            </a:endParaRPr>
          </a:p>
        </p:txBody>
      </p:sp>
      <p:sp>
        <p:nvSpPr>
          <p:cNvPr id="36884" name="文本框 7">
            <a:extLst>
              <a:ext uri="{FF2B5EF4-FFF2-40B4-BE49-F238E27FC236}">
                <a16:creationId xmlns:a16="http://schemas.microsoft.com/office/drawing/2014/main" id="{590738C5-E46D-83C5-6D5B-3C69609045F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087812" y="2171701"/>
            <a:ext cx="10715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</a:t>
            </a:r>
          </a:p>
        </p:txBody>
      </p:sp>
      <p:sp>
        <p:nvSpPr>
          <p:cNvPr id="36885" name="文本框 8">
            <a:extLst>
              <a:ext uri="{FF2B5EF4-FFF2-40B4-BE49-F238E27FC236}">
                <a16:creationId xmlns:a16="http://schemas.microsoft.com/office/drawing/2014/main" id="{F4AB25D6-58C8-FAB7-2901-8C693C50B9F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28332" y="2169319"/>
            <a:ext cx="10715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</a:t>
            </a:r>
          </a:p>
        </p:txBody>
      </p:sp>
      <p:sp>
        <p:nvSpPr>
          <p:cNvPr id="36886" name="文本框 6">
            <a:extLst>
              <a:ext uri="{FF2B5EF4-FFF2-40B4-BE49-F238E27FC236}">
                <a16:creationId xmlns:a16="http://schemas.microsoft.com/office/drawing/2014/main" id="{BBAA2CF5-0070-8BC5-33AE-243B6987F02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741862" y="2006601"/>
            <a:ext cx="14462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THF-serum</a:t>
            </a:r>
          </a:p>
        </p:txBody>
      </p:sp>
      <p:sp>
        <p:nvSpPr>
          <p:cNvPr id="36887" name="文本框 7">
            <a:extLst>
              <a:ext uri="{FF2B5EF4-FFF2-40B4-BE49-F238E27FC236}">
                <a16:creationId xmlns:a16="http://schemas.microsoft.com/office/drawing/2014/main" id="{FE82C0BD-9E69-E2FD-C8B6-5702A6D3683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54613" y="1903413"/>
            <a:ext cx="158750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THF-serum</a:t>
            </a: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6888" name="文本框 8">
            <a:extLst>
              <a:ext uri="{FF2B5EF4-FFF2-40B4-BE49-F238E27FC236}">
                <a16:creationId xmlns:a16="http://schemas.microsoft.com/office/drawing/2014/main" id="{7CD96FAF-09D1-DDDA-DF41-6E85670BA3F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618957" y="1986756"/>
            <a:ext cx="1390650" cy="401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THF-serum</a:t>
            </a: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6889" name="文本框 6">
            <a:extLst>
              <a:ext uri="{FF2B5EF4-FFF2-40B4-BE49-F238E27FC236}">
                <a16:creationId xmlns:a16="http://schemas.microsoft.com/office/drawing/2014/main" id="{B8C474A0-2187-B489-A2D4-B725DF2F5E0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872162" y="2005013"/>
            <a:ext cx="14446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</p:txBody>
      </p:sp>
      <p:sp>
        <p:nvSpPr>
          <p:cNvPr id="36890" name="文本框 7">
            <a:extLst>
              <a:ext uri="{FF2B5EF4-FFF2-40B4-BE49-F238E27FC236}">
                <a16:creationId xmlns:a16="http://schemas.microsoft.com/office/drawing/2014/main" id="{DBFAC0D0-670B-4FC1-D7BC-A014A0444DE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279356" y="1732757"/>
            <a:ext cx="1876425" cy="554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6891" name="文本框 8">
            <a:extLst>
              <a:ext uri="{FF2B5EF4-FFF2-40B4-BE49-F238E27FC236}">
                <a16:creationId xmlns:a16="http://schemas.microsoft.com/office/drawing/2014/main" id="{27A68A87-D207-F649-371E-EA19CDF5ABF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678613" y="1987550"/>
            <a:ext cx="139065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89" name="图片 3" descr="Cleave-caspase1">
            <a:extLst>
              <a:ext uri="{FF2B5EF4-FFF2-40B4-BE49-F238E27FC236}">
                <a16:creationId xmlns:a16="http://schemas.microsoft.com/office/drawing/2014/main" id="{ED2691E1-74D0-9EAA-4A57-50EB99E6AD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1" t="6306" b="6252"/>
          <a:stretch>
            <a:fillRect/>
          </a:stretch>
        </p:blipFill>
        <p:spPr bwMode="auto">
          <a:xfrm>
            <a:off x="1908175" y="2916238"/>
            <a:ext cx="5511800" cy="2968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890" name="文本框 30">
            <a:extLst>
              <a:ext uri="{FF2B5EF4-FFF2-40B4-BE49-F238E27FC236}">
                <a16:creationId xmlns:a16="http://schemas.microsoft.com/office/drawing/2014/main" id="{87F23AC1-6B8B-85A4-3EDE-EFBCEA0592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925" y="1154113"/>
            <a:ext cx="46275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cGAMP-RU521</a:t>
            </a:r>
            <a:r>
              <a:rPr lang="zh-CN" altLang="en-US" sz="1800"/>
              <a:t>细胞</a:t>
            </a:r>
            <a:r>
              <a:rPr lang="en-US" altLang="zh-CN" sz="1800"/>
              <a:t>caspase1</a:t>
            </a:r>
            <a:r>
              <a:rPr lang="zh-CN" altLang="en-US" sz="1800"/>
              <a:t>，</a:t>
            </a:r>
            <a:r>
              <a:rPr lang="en-US" altLang="zh-CN" sz="1800"/>
              <a:t>n=3</a:t>
            </a:r>
          </a:p>
        </p:txBody>
      </p:sp>
      <p:sp>
        <p:nvSpPr>
          <p:cNvPr id="37891" name="文本框 18">
            <a:extLst>
              <a:ext uri="{FF2B5EF4-FFF2-40B4-BE49-F238E27FC236}">
                <a16:creationId xmlns:a16="http://schemas.microsoft.com/office/drawing/2014/main" id="{A5336B9A-C0AA-D591-D4AA-E441E6174C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2863" y="3046413"/>
            <a:ext cx="8826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7892" name="文本框 19">
            <a:extLst>
              <a:ext uri="{FF2B5EF4-FFF2-40B4-BE49-F238E27FC236}">
                <a16:creationId xmlns:a16="http://schemas.microsoft.com/office/drawing/2014/main" id="{825EE1EA-0F31-6728-603B-43B4042A50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6988" y="3173413"/>
            <a:ext cx="8810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7893" name="文本框 20">
            <a:extLst>
              <a:ext uri="{FF2B5EF4-FFF2-40B4-BE49-F238E27FC236}">
                <a16:creationId xmlns:a16="http://schemas.microsoft.com/office/drawing/2014/main" id="{8BBBCA03-BDC5-1D92-A738-C89FCF5F0D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6988" y="3316288"/>
            <a:ext cx="8810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7894" name="文本框 21">
            <a:extLst>
              <a:ext uri="{FF2B5EF4-FFF2-40B4-BE49-F238E27FC236}">
                <a16:creationId xmlns:a16="http://schemas.microsoft.com/office/drawing/2014/main" id="{07A03888-5F24-005A-0CCB-A57FFDD0E5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0013" y="3575050"/>
            <a:ext cx="7350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7895" name="文本框 22">
            <a:extLst>
              <a:ext uri="{FF2B5EF4-FFF2-40B4-BE49-F238E27FC236}">
                <a16:creationId xmlns:a16="http://schemas.microsoft.com/office/drawing/2014/main" id="{7BEF89B7-7BA0-DDEC-9598-DD77378757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5888" y="3835400"/>
            <a:ext cx="8112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7896" name="文本框 23">
            <a:extLst>
              <a:ext uri="{FF2B5EF4-FFF2-40B4-BE49-F238E27FC236}">
                <a16:creationId xmlns:a16="http://schemas.microsoft.com/office/drawing/2014/main" id="{E131CC87-5A8E-A6D8-6A0B-77623DF1F6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5888" y="4117975"/>
            <a:ext cx="7366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7897" name="文本框 24">
            <a:extLst>
              <a:ext uri="{FF2B5EF4-FFF2-40B4-BE49-F238E27FC236}">
                <a16:creationId xmlns:a16="http://schemas.microsoft.com/office/drawing/2014/main" id="{CB98F962-98F9-CA22-F124-0CE4827AD5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0013" y="4460875"/>
            <a:ext cx="7350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7898" name="文本框 25">
            <a:extLst>
              <a:ext uri="{FF2B5EF4-FFF2-40B4-BE49-F238E27FC236}">
                <a16:creationId xmlns:a16="http://schemas.microsoft.com/office/drawing/2014/main" id="{918FAA87-6D76-2227-D298-ACDDB46077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0013" y="4768850"/>
            <a:ext cx="7350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7899" name="文本框 26">
            <a:extLst>
              <a:ext uri="{FF2B5EF4-FFF2-40B4-BE49-F238E27FC236}">
                <a16:creationId xmlns:a16="http://schemas.microsoft.com/office/drawing/2014/main" id="{129A7023-4F61-B8DE-AADC-8A6915064C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0013" y="5346700"/>
            <a:ext cx="7350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6FA4DFDD-6033-8149-FC3D-52BCB87EFE4B}"/>
              </a:ext>
            </a:extLst>
          </p:cNvPr>
          <p:cNvSpPr/>
          <p:nvPr/>
        </p:nvSpPr>
        <p:spPr>
          <a:xfrm>
            <a:off x="2435225" y="5295900"/>
            <a:ext cx="4090988" cy="33337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7901" name="文本框 56">
            <a:extLst>
              <a:ext uri="{FF2B5EF4-FFF2-40B4-BE49-F238E27FC236}">
                <a16:creationId xmlns:a16="http://schemas.microsoft.com/office/drawing/2014/main" id="{2EE1B3E9-B8AC-2825-F835-56D36215EA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5750" y="4079875"/>
            <a:ext cx="993775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DEA67A41-D7CC-C4F8-7752-44AF381F3878}"/>
              </a:ext>
            </a:extLst>
          </p:cNvPr>
          <p:cNvSpPr/>
          <p:nvPr/>
        </p:nvSpPr>
        <p:spPr>
          <a:xfrm>
            <a:off x="2508250" y="4413250"/>
            <a:ext cx="3956050" cy="31591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7903" name="文本框 56">
            <a:extLst>
              <a:ext uri="{FF2B5EF4-FFF2-40B4-BE49-F238E27FC236}">
                <a16:creationId xmlns:a16="http://schemas.microsoft.com/office/drawing/2014/main" id="{46A03BFA-2C46-E188-B402-29D3E09B5E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32375" y="5649913"/>
            <a:ext cx="1717675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  <a:sym typeface="宋体" panose="02010600030101010101" pitchFamily="2" charset="-122"/>
              </a:rPr>
              <a:t> caspase1</a:t>
            </a: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7904" name="文本框 3">
            <a:extLst>
              <a:ext uri="{FF2B5EF4-FFF2-40B4-BE49-F238E27FC236}">
                <a16:creationId xmlns:a16="http://schemas.microsoft.com/office/drawing/2014/main" id="{5F768CB3-E412-E313-02DA-44D828D9B7F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554287" y="2616201"/>
            <a:ext cx="5508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</a:p>
        </p:txBody>
      </p:sp>
      <p:sp>
        <p:nvSpPr>
          <p:cNvPr id="37905" name="文本框 4">
            <a:extLst>
              <a:ext uri="{FF2B5EF4-FFF2-40B4-BE49-F238E27FC236}">
                <a16:creationId xmlns:a16="http://schemas.microsoft.com/office/drawing/2014/main" id="{2CD3D1DC-8227-04F4-096F-A7EB2576C9A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877344" y="2537619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7906" name="文本框 5">
            <a:extLst>
              <a:ext uri="{FF2B5EF4-FFF2-40B4-BE49-F238E27FC236}">
                <a16:creationId xmlns:a16="http://schemas.microsoft.com/office/drawing/2014/main" id="{94A8E8D5-9D7F-7332-7801-E7A61EE3699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217862" y="2614613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</a:p>
        </p:txBody>
      </p:sp>
      <p:sp>
        <p:nvSpPr>
          <p:cNvPr id="37907" name="文本框 6">
            <a:extLst>
              <a:ext uri="{FF2B5EF4-FFF2-40B4-BE49-F238E27FC236}">
                <a16:creationId xmlns:a16="http://schemas.microsoft.com/office/drawing/2014/main" id="{C403F582-34A2-75D5-2629-C840AD754AA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82962" y="2443163"/>
            <a:ext cx="9429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GAMP</a:t>
            </a:r>
            <a:endParaRPr lang="en-US" altLang="zh-CN" sz="1000" baseline="-25000">
              <a:latin typeface="Times New Roman" panose="02020603050405020304" pitchFamily="18" charset="0"/>
            </a:endParaRPr>
          </a:p>
        </p:txBody>
      </p:sp>
      <p:sp>
        <p:nvSpPr>
          <p:cNvPr id="37908" name="文本框 7">
            <a:extLst>
              <a:ext uri="{FF2B5EF4-FFF2-40B4-BE49-F238E27FC236}">
                <a16:creationId xmlns:a16="http://schemas.microsoft.com/office/drawing/2014/main" id="{50877254-09EE-126D-C146-F2EBDC443A4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657600" y="2387600"/>
            <a:ext cx="10715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</a:t>
            </a:r>
          </a:p>
        </p:txBody>
      </p:sp>
      <p:sp>
        <p:nvSpPr>
          <p:cNvPr id="37909" name="文本框 8">
            <a:extLst>
              <a:ext uri="{FF2B5EF4-FFF2-40B4-BE49-F238E27FC236}">
                <a16:creationId xmlns:a16="http://schemas.microsoft.com/office/drawing/2014/main" id="{71F4A25E-11F1-03FD-DEB5-185585750CB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998912" y="2387601"/>
            <a:ext cx="10715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</a:t>
            </a:r>
          </a:p>
        </p:txBody>
      </p:sp>
      <p:sp>
        <p:nvSpPr>
          <p:cNvPr id="37910" name="文本框 6">
            <a:extLst>
              <a:ext uri="{FF2B5EF4-FFF2-40B4-BE49-F238E27FC236}">
                <a16:creationId xmlns:a16="http://schemas.microsoft.com/office/drawing/2014/main" id="{1B48F6F4-CEF1-9D44-E7CF-078BAB44982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38625" y="2220913"/>
            <a:ext cx="14478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THF-serum</a:t>
            </a:r>
          </a:p>
        </p:txBody>
      </p:sp>
      <p:sp>
        <p:nvSpPr>
          <p:cNvPr id="37911" name="文本框 7">
            <a:extLst>
              <a:ext uri="{FF2B5EF4-FFF2-40B4-BE49-F238E27FC236}">
                <a16:creationId xmlns:a16="http://schemas.microsoft.com/office/drawing/2014/main" id="{FEFEF3BB-4CEE-858E-0DA1-0B8E39ECC3D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42632" y="2226468"/>
            <a:ext cx="1447800" cy="227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THF-serum</a:t>
            </a: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7912" name="文本框 8">
            <a:extLst>
              <a:ext uri="{FF2B5EF4-FFF2-40B4-BE49-F238E27FC236}">
                <a16:creationId xmlns:a16="http://schemas.microsoft.com/office/drawing/2014/main" id="{1F0DFACC-6C97-A595-4A5E-AF66138581B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901407" y="2202656"/>
            <a:ext cx="1390650" cy="401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THF-serum</a:t>
            </a: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7913" name="文本框 6">
            <a:extLst>
              <a:ext uri="{FF2B5EF4-FFF2-40B4-BE49-F238E27FC236}">
                <a16:creationId xmlns:a16="http://schemas.microsoft.com/office/drawing/2014/main" id="{537BF7A0-4BB1-7B0D-6844-D09C564CB3B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54613" y="2220913"/>
            <a:ext cx="14478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</p:txBody>
      </p:sp>
      <p:sp>
        <p:nvSpPr>
          <p:cNvPr id="37914" name="文本框 7">
            <a:extLst>
              <a:ext uri="{FF2B5EF4-FFF2-40B4-BE49-F238E27FC236}">
                <a16:creationId xmlns:a16="http://schemas.microsoft.com/office/drawing/2014/main" id="{F7E158C6-6B55-7B08-B008-D01CB7B12FC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515769" y="2226469"/>
            <a:ext cx="1387475" cy="315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7915" name="文本框 8">
            <a:extLst>
              <a:ext uri="{FF2B5EF4-FFF2-40B4-BE49-F238E27FC236}">
                <a16:creationId xmlns:a16="http://schemas.microsoft.com/office/drawing/2014/main" id="{D4F32859-AF1F-5349-9DC1-9CD04585C69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888832" y="2202656"/>
            <a:ext cx="1390650" cy="401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3" name="图片 3" descr="gapdh">
            <a:extLst>
              <a:ext uri="{FF2B5EF4-FFF2-40B4-BE49-F238E27FC236}">
                <a16:creationId xmlns:a16="http://schemas.microsoft.com/office/drawing/2014/main" id="{71060B90-84CC-1D04-2050-6109F0D7A38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8" b="7265"/>
          <a:stretch>
            <a:fillRect/>
          </a:stretch>
        </p:blipFill>
        <p:spPr bwMode="auto">
          <a:xfrm>
            <a:off x="3127375" y="5614988"/>
            <a:ext cx="3824288" cy="2279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914" name="图片 4" descr="gadmd">
            <a:extLst>
              <a:ext uri="{FF2B5EF4-FFF2-40B4-BE49-F238E27FC236}">
                <a16:creationId xmlns:a16="http://schemas.microsoft.com/office/drawing/2014/main" id="{156491B1-9706-59D1-D853-DF0342EF5A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98" r="2811" b="4742"/>
          <a:stretch>
            <a:fillRect/>
          </a:stretch>
        </p:blipFill>
        <p:spPr bwMode="auto">
          <a:xfrm>
            <a:off x="3127375" y="1979613"/>
            <a:ext cx="4381500" cy="26050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915" name="文本框 30">
            <a:extLst>
              <a:ext uri="{FF2B5EF4-FFF2-40B4-BE49-F238E27FC236}">
                <a16:creationId xmlns:a16="http://schemas.microsoft.com/office/drawing/2014/main" id="{51EA9204-4C0E-5F22-7CFF-66588CE1AA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48609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cGAMP-RU521</a:t>
            </a:r>
            <a:r>
              <a:rPr lang="zh-CN" altLang="en-US" sz="1800"/>
              <a:t>细胞</a:t>
            </a:r>
            <a:r>
              <a:rPr lang="en-US" altLang="zh-CN" sz="1800"/>
              <a:t>GSDMD-N</a:t>
            </a:r>
            <a:r>
              <a:rPr lang="en-US" altLang="zh-CN" sz="1800">
                <a:sym typeface="宋体" panose="02010600030101010101" pitchFamily="2" charset="-122"/>
              </a:rPr>
              <a:t>,</a:t>
            </a:r>
            <a:r>
              <a:rPr lang="en-US" altLang="zh-CN" sz="1800"/>
              <a:t>N=3</a:t>
            </a:r>
          </a:p>
        </p:txBody>
      </p:sp>
      <p:sp>
        <p:nvSpPr>
          <p:cNvPr id="38916" name="文本框 18">
            <a:extLst>
              <a:ext uri="{FF2B5EF4-FFF2-40B4-BE49-F238E27FC236}">
                <a16:creationId xmlns:a16="http://schemas.microsoft.com/office/drawing/2014/main" id="{BEE771FD-10C9-675B-C4EC-CA7C66EAD5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5088" y="2112963"/>
            <a:ext cx="752475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8917" name="文本框 19">
            <a:extLst>
              <a:ext uri="{FF2B5EF4-FFF2-40B4-BE49-F238E27FC236}">
                <a16:creationId xmlns:a16="http://schemas.microsoft.com/office/drawing/2014/main" id="{6B3E9AC0-435A-3D92-6D0A-0B036D2B81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9213" y="2239963"/>
            <a:ext cx="8810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8918" name="文本框 20">
            <a:extLst>
              <a:ext uri="{FF2B5EF4-FFF2-40B4-BE49-F238E27FC236}">
                <a16:creationId xmlns:a16="http://schemas.microsoft.com/office/drawing/2014/main" id="{105CBCF2-3AE6-CC4B-432A-89646F51B6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9213" y="2455863"/>
            <a:ext cx="8810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8919" name="文本框 21">
            <a:extLst>
              <a:ext uri="{FF2B5EF4-FFF2-40B4-BE49-F238E27FC236}">
                <a16:creationId xmlns:a16="http://schemas.microsoft.com/office/drawing/2014/main" id="{A812C8D9-9CFE-613D-D9E6-5BE1551C7A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62238" y="2571750"/>
            <a:ext cx="625475" cy="227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8920" name="文本框 22">
            <a:extLst>
              <a:ext uri="{FF2B5EF4-FFF2-40B4-BE49-F238E27FC236}">
                <a16:creationId xmlns:a16="http://schemas.microsoft.com/office/drawing/2014/main" id="{957579B9-FFEA-2E64-78E8-25AAB236E7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8113" y="2759075"/>
            <a:ext cx="692150" cy="227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8921" name="文本框 23">
            <a:extLst>
              <a:ext uri="{FF2B5EF4-FFF2-40B4-BE49-F238E27FC236}">
                <a16:creationId xmlns:a16="http://schemas.microsoft.com/office/drawing/2014/main" id="{9BCAA521-2288-14B3-19B3-75FE87914A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8113" y="3113088"/>
            <a:ext cx="6270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8922" name="文本框 24">
            <a:extLst>
              <a:ext uri="{FF2B5EF4-FFF2-40B4-BE49-F238E27FC236}">
                <a16:creationId xmlns:a16="http://schemas.microsoft.com/office/drawing/2014/main" id="{A3E9D2BB-48E1-E8FA-C98B-02E4C2077B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62238" y="3457575"/>
            <a:ext cx="625475" cy="227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8923" name="文本框 25">
            <a:extLst>
              <a:ext uri="{FF2B5EF4-FFF2-40B4-BE49-F238E27FC236}">
                <a16:creationId xmlns:a16="http://schemas.microsoft.com/office/drawing/2014/main" id="{39A2ADE6-13F4-E435-4799-CFD2E5FCF4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62238" y="3763963"/>
            <a:ext cx="625475" cy="225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8924" name="文本框 26">
            <a:extLst>
              <a:ext uri="{FF2B5EF4-FFF2-40B4-BE49-F238E27FC236}">
                <a16:creationId xmlns:a16="http://schemas.microsoft.com/office/drawing/2014/main" id="{6B743DCF-2095-7756-810F-4B46B4D71A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62238" y="4343400"/>
            <a:ext cx="625475" cy="227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38925" name="文本框 18">
            <a:extLst>
              <a:ext uri="{FF2B5EF4-FFF2-40B4-BE49-F238E27FC236}">
                <a16:creationId xmlns:a16="http://schemas.microsoft.com/office/drawing/2014/main" id="{011DFA41-11A1-3D37-62A3-A85708DCA2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90800" y="5505450"/>
            <a:ext cx="658813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38926" name="文本框 19">
            <a:extLst>
              <a:ext uri="{FF2B5EF4-FFF2-40B4-BE49-F238E27FC236}">
                <a16:creationId xmlns:a16="http://schemas.microsoft.com/office/drawing/2014/main" id="{3053D7DD-283A-7FBB-EDFC-FB56F1C5F5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3338" y="5630863"/>
            <a:ext cx="658812" cy="93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38927" name="文本框 20">
            <a:extLst>
              <a:ext uri="{FF2B5EF4-FFF2-40B4-BE49-F238E27FC236}">
                <a16:creationId xmlns:a16="http://schemas.microsoft.com/office/drawing/2014/main" id="{BA5F94D4-9DF6-3B0C-C361-08BBD44314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3338" y="5776913"/>
            <a:ext cx="658812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38928" name="文本框 21">
            <a:extLst>
              <a:ext uri="{FF2B5EF4-FFF2-40B4-BE49-F238E27FC236}">
                <a16:creationId xmlns:a16="http://schemas.microsoft.com/office/drawing/2014/main" id="{789F14DA-7CEF-0EDF-314D-B21FD9C96B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5250" y="6034088"/>
            <a:ext cx="549275" cy="93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38929" name="文本框 22">
            <a:extLst>
              <a:ext uri="{FF2B5EF4-FFF2-40B4-BE49-F238E27FC236}">
                <a16:creationId xmlns:a16="http://schemas.microsoft.com/office/drawing/2014/main" id="{F6ECA7A7-5E34-58A0-A9DB-5A578CC086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7475" y="6221413"/>
            <a:ext cx="604838" cy="93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38930" name="文本框 23">
            <a:extLst>
              <a:ext uri="{FF2B5EF4-FFF2-40B4-BE49-F238E27FC236}">
                <a16:creationId xmlns:a16="http://schemas.microsoft.com/office/drawing/2014/main" id="{1C4A4856-57BD-9C5E-8268-1861307DEC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1125" y="6577013"/>
            <a:ext cx="54927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38931" name="文本框 24">
            <a:extLst>
              <a:ext uri="{FF2B5EF4-FFF2-40B4-BE49-F238E27FC236}">
                <a16:creationId xmlns:a16="http://schemas.microsoft.com/office/drawing/2014/main" id="{459D0358-21AD-E9D2-02C6-A489985B72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5250" y="6919913"/>
            <a:ext cx="549275" cy="93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38932" name="文本框 25">
            <a:extLst>
              <a:ext uri="{FF2B5EF4-FFF2-40B4-BE49-F238E27FC236}">
                <a16:creationId xmlns:a16="http://schemas.microsoft.com/office/drawing/2014/main" id="{6606A729-54BD-382C-2451-A164975DDC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5250" y="7227888"/>
            <a:ext cx="549275" cy="92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38933" name="文本框 26">
            <a:extLst>
              <a:ext uri="{FF2B5EF4-FFF2-40B4-BE49-F238E27FC236}">
                <a16:creationId xmlns:a16="http://schemas.microsoft.com/office/drawing/2014/main" id="{3403A975-7609-D6CC-B3BE-2A349DF2BA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5250" y="7805738"/>
            <a:ext cx="549275" cy="93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615EB88F-33E6-7F2C-2D32-F68EFFCA5CCB}"/>
              </a:ext>
            </a:extLst>
          </p:cNvPr>
          <p:cNvSpPr/>
          <p:nvPr/>
        </p:nvSpPr>
        <p:spPr>
          <a:xfrm>
            <a:off x="3544888" y="6805613"/>
            <a:ext cx="2970212" cy="26987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D68BCE7D-6159-1D67-3D1F-32A30107A4BA}"/>
              </a:ext>
            </a:extLst>
          </p:cNvPr>
          <p:cNvSpPr/>
          <p:nvPr/>
        </p:nvSpPr>
        <p:spPr>
          <a:xfrm>
            <a:off x="3611563" y="3562350"/>
            <a:ext cx="3460750" cy="2921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8936" name="文本框 56">
            <a:extLst>
              <a:ext uri="{FF2B5EF4-FFF2-40B4-BE49-F238E27FC236}">
                <a16:creationId xmlns:a16="http://schemas.microsoft.com/office/drawing/2014/main" id="{02ECE202-AF86-6627-FD20-2CE4329F35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3725" y="7091363"/>
            <a:ext cx="10668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38937" name="文本框 56">
            <a:extLst>
              <a:ext uri="{FF2B5EF4-FFF2-40B4-BE49-F238E27FC236}">
                <a16:creationId xmlns:a16="http://schemas.microsoft.com/office/drawing/2014/main" id="{028D5B9B-021F-A275-1E6E-DFB8369059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68988" y="3806825"/>
            <a:ext cx="1335087" cy="312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  <a:sym typeface="宋体" panose="02010600030101010101" pitchFamily="2" charset="-122"/>
              </a:rPr>
              <a:t>GSDMD-N</a:t>
            </a: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F2BEA45C-B177-1FF9-527E-68E8DD71B590}"/>
              </a:ext>
            </a:extLst>
          </p:cNvPr>
          <p:cNvSpPr/>
          <p:nvPr/>
        </p:nvSpPr>
        <p:spPr>
          <a:xfrm>
            <a:off x="3584575" y="2759075"/>
            <a:ext cx="3436938" cy="25717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38939" name="文本框 56">
            <a:extLst>
              <a:ext uri="{FF2B5EF4-FFF2-40B4-BE49-F238E27FC236}">
                <a16:creationId xmlns:a16="http://schemas.microsoft.com/office/drawing/2014/main" id="{18BF4B14-15A6-4B00-388C-EB3D8F93F0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7413" y="2425700"/>
            <a:ext cx="1154112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  <a:sym typeface="宋体" panose="02010600030101010101" pitchFamily="2" charset="-122"/>
              </a:rPr>
              <a:t>GSDMD</a:t>
            </a: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38940" name="文本框 3">
            <a:extLst>
              <a:ext uri="{FF2B5EF4-FFF2-40B4-BE49-F238E27FC236}">
                <a16:creationId xmlns:a16="http://schemas.microsoft.com/office/drawing/2014/main" id="{23A28117-2050-2A40-648F-B2FF9BFCD63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485356" y="1681957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</a:p>
        </p:txBody>
      </p:sp>
      <p:sp>
        <p:nvSpPr>
          <p:cNvPr id="38941" name="文本框 4">
            <a:extLst>
              <a:ext uri="{FF2B5EF4-FFF2-40B4-BE49-F238E27FC236}">
                <a16:creationId xmlns:a16="http://schemas.microsoft.com/office/drawing/2014/main" id="{203AE758-9D70-2294-A1A2-9D2B281BC5E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09206" y="1604169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8942" name="文本框 5">
            <a:extLst>
              <a:ext uri="{FF2B5EF4-FFF2-40B4-BE49-F238E27FC236}">
                <a16:creationId xmlns:a16="http://schemas.microsoft.com/office/drawing/2014/main" id="{002EE70D-C60C-423C-1033-2F094B2187F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151313" y="1684338"/>
            <a:ext cx="5508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</a:p>
        </p:txBody>
      </p:sp>
      <p:sp>
        <p:nvSpPr>
          <p:cNvPr id="38943" name="文本框 6">
            <a:extLst>
              <a:ext uri="{FF2B5EF4-FFF2-40B4-BE49-F238E27FC236}">
                <a16:creationId xmlns:a16="http://schemas.microsoft.com/office/drawing/2014/main" id="{4A001C42-4D3F-6B75-D8A6-3F071B407F3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318000" y="1511301"/>
            <a:ext cx="9413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GAMP</a:t>
            </a:r>
            <a:endParaRPr lang="en-US" altLang="zh-CN" sz="1000" baseline="-25000">
              <a:latin typeface="Times New Roman" panose="02020603050405020304" pitchFamily="18" charset="0"/>
            </a:endParaRPr>
          </a:p>
        </p:txBody>
      </p:sp>
      <p:sp>
        <p:nvSpPr>
          <p:cNvPr id="38944" name="文本框 7">
            <a:extLst>
              <a:ext uri="{FF2B5EF4-FFF2-40B4-BE49-F238E27FC236}">
                <a16:creationId xmlns:a16="http://schemas.microsoft.com/office/drawing/2014/main" id="{5668265D-DA50-0D16-A95F-F22B7FFBAF1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17231" y="14533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</a:t>
            </a:r>
          </a:p>
        </p:txBody>
      </p:sp>
      <p:sp>
        <p:nvSpPr>
          <p:cNvPr id="38945" name="文本框 8">
            <a:extLst>
              <a:ext uri="{FF2B5EF4-FFF2-40B4-BE49-F238E27FC236}">
                <a16:creationId xmlns:a16="http://schemas.microsoft.com/office/drawing/2014/main" id="{B8D623CC-6677-67D2-BBB2-83F6B19A1D9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859337" y="1452563"/>
            <a:ext cx="10699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</a:t>
            </a:r>
          </a:p>
        </p:txBody>
      </p:sp>
      <p:sp>
        <p:nvSpPr>
          <p:cNvPr id="38946" name="文本框 6">
            <a:extLst>
              <a:ext uri="{FF2B5EF4-FFF2-40B4-BE49-F238E27FC236}">
                <a16:creationId xmlns:a16="http://schemas.microsoft.com/office/drawing/2014/main" id="{D457BE47-9743-845E-22F7-56E2FC8D918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00637" y="1289051"/>
            <a:ext cx="14462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THF-serum</a:t>
            </a:r>
          </a:p>
        </p:txBody>
      </p:sp>
      <p:sp>
        <p:nvSpPr>
          <p:cNvPr id="38947" name="文本框 7">
            <a:extLst>
              <a:ext uri="{FF2B5EF4-FFF2-40B4-BE49-F238E27FC236}">
                <a16:creationId xmlns:a16="http://schemas.microsoft.com/office/drawing/2014/main" id="{B32B3A5C-FA99-7860-969A-53A689778A9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01469" y="1291432"/>
            <a:ext cx="1449387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THF-serum</a:t>
            </a: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8948" name="文本框 8">
            <a:extLst>
              <a:ext uri="{FF2B5EF4-FFF2-40B4-BE49-F238E27FC236}">
                <a16:creationId xmlns:a16="http://schemas.microsoft.com/office/drawing/2014/main" id="{76440744-69A5-6540-5FB1-1EF3D08A510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61038" y="1268413"/>
            <a:ext cx="1392237" cy="401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THF-serum</a:t>
            </a: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8949" name="文本框 6">
            <a:extLst>
              <a:ext uri="{FF2B5EF4-FFF2-40B4-BE49-F238E27FC236}">
                <a16:creationId xmlns:a16="http://schemas.microsoft.com/office/drawing/2014/main" id="{1A4B71EC-527E-79AB-02BC-601FC3E9163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945187" y="1289051"/>
            <a:ext cx="14462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</p:txBody>
      </p:sp>
      <p:sp>
        <p:nvSpPr>
          <p:cNvPr id="38950" name="文本框 7">
            <a:extLst>
              <a:ext uri="{FF2B5EF4-FFF2-40B4-BE49-F238E27FC236}">
                <a16:creationId xmlns:a16="http://schemas.microsoft.com/office/drawing/2014/main" id="{6A90F4BE-6AF4-BCCA-8BC4-62FD9BD6196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234112" y="1295401"/>
            <a:ext cx="1389063" cy="315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8951" name="文本框 8">
            <a:extLst>
              <a:ext uri="{FF2B5EF4-FFF2-40B4-BE49-F238E27FC236}">
                <a16:creationId xmlns:a16="http://schemas.microsoft.com/office/drawing/2014/main" id="{755A16DC-8BA9-7D07-5DAF-4DAEE598201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605588" y="1268413"/>
            <a:ext cx="1392237" cy="401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8952" name="文本框 3">
            <a:extLst>
              <a:ext uri="{FF2B5EF4-FFF2-40B4-BE49-F238E27FC236}">
                <a16:creationId xmlns:a16="http://schemas.microsoft.com/office/drawing/2014/main" id="{57A10D42-4395-EC6C-06A2-54EC5544768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98837" y="5254626"/>
            <a:ext cx="5508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</a:p>
        </p:txBody>
      </p:sp>
      <p:sp>
        <p:nvSpPr>
          <p:cNvPr id="38953" name="文本框 4">
            <a:extLst>
              <a:ext uri="{FF2B5EF4-FFF2-40B4-BE49-F238E27FC236}">
                <a16:creationId xmlns:a16="http://schemas.microsoft.com/office/drawing/2014/main" id="{8712E71C-C420-EEFB-38BA-FFA007E4197A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721894" y="5176044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38954" name="文本框 5">
            <a:extLst>
              <a:ext uri="{FF2B5EF4-FFF2-40B4-BE49-F238E27FC236}">
                <a16:creationId xmlns:a16="http://schemas.microsoft.com/office/drawing/2014/main" id="{3851BAF8-C710-AD5D-F5FA-4DE789DF08E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990182" y="5252244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</a:p>
        </p:txBody>
      </p:sp>
      <p:sp>
        <p:nvSpPr>
          <p:cNvPr id="38955" name="文本框 6">
            <a:extLst>
              <a:ext uri="{FF2B5EF4-FFF2-40B4-BE49-F238E27FC236}">
                <a16:creationId xmlns:a16="http://schemas.microsoft.com/office/drawing/2014/main" id="{0C2C7681-1E18-CD98-AEA8-2470B79F478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086225" y="5083176"/>
            <a:ext cx="9413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GAMP</a:t>
            </a:r>
            <a:endParaRPr lang="en-US" altLang="zh-CN" sz="1000" baseline="-25000">
              <a:latin typeface="Times New Roman" panose="02020603050405020304" pitchFamily="18" charset="0"/>
            </a:endParaRPr>
          </a:p>
        </p:txBody>
      </p:sp>
      <p:sp>
        <p:nvSpPr>
          <p:cNvPr id="38956" name="文本框 7">
            <a:extLst>
              <a:ext uri="{FF2B5EF4-FFF2-40B4-BE49-F238E27FC236}">
                <a16:creationId xmlns:a16="http://schemas.microsoft.com/office/drawing/2014/main" id="{2F29DBEE-3907-8666-88B3-BBF9D2C1056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85457" y="5023644"/>
            <a:ext cx="10715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</a:t>
            </a:r>
          </a:p>
        </p:txBody>
      </p:sp>
      <p:sp>
        <p:nvSpPr>
          <p:cNvPr id="38957" name="文本框 8">
            <a:extLst>
              <a:ext uri="{FF2B5EF4-FFF2-40B4-BE49-F238E27FC236}">
                <a16:creationId xmlns:a16="http://schemas.microsoft.com/office/drawing/2014/main" id="{ABC92F45-D1FA-FF86-2770-38B8FA1D4F8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55332" y="5023644"/>
            <a:ext cx="10715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</a:t>
            </a:r>
          </a:p>
        </p:txBody>
      </p:sp>
      <p:sp>
        <p:nvSpPr>
          <p:cNvPr id="38958" name="文本框 6">
            <a:extLst>
              <a:ext uri="{FF2B5EF4-FFF2-40B4-BE49-F238E27FC236}">
                <a16:creationId xmlns:a16="http://schemas.microsoft.com/office/drawing/2014/main" id="{A81164BC-F89F-B834-CA57-662677E9177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724400" y="4859338"/>
            <a:ext cx="14478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THF-serum</a:t>
            </a:r>
          </a:p>
        </p:txBody>
      </p:sp>
      <p:sp>
        <p:nvSpPr>
          <p:cNvPr id="38959" name="文本框 7">
            <a:extLst>
              <a:ext uri="{FF2B5EF4-FFF2-40B4-BE49-F238E27FC236}">
                <a16:creationId xmlns:a16="http://schemas.microsoft.com/office/drawing/2014/main" id="{2C642AE5-CE2D-06C6-3BC0-0593269F0F8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955381" y="4863307"/>
            <a:ext cx="1449387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THF-serum</a:t>
            </a: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8960" name="文本框 8">
            <a:extLst>
              <a:ext uri="{FF2B5EF4-FFF2-40B4-BE49-F238E27FC236}">
                <a16:creationId xmlns:a16="http://schemas.microsoft.com/office/drawing/2014/main" id="{057A0127-81F8-854D-FBE2-1BEBE6B737C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243513" y="4841875"/>
            <a:ext cx="139065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THF-serum</a:t>
            </a: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8961" name="文本框 6">
            <a:extLst>
              <a:ext uri="{FF2B5EF4-FFF2-40B4-BE49-F238E27FC236}">
                <a16:creationId xmlns:a16="http://schemas.microsoft.com/office/drawing/2014/main" id="{83635081-5610-D521-4FE0-A5353FC6BEF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24488" y="4857750"/>
            <a:ext cx="14478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</p:txBody>
      </p:sp>
      <p:sp>
        <p:nvSpPr>
          <p:cNvPr id="38962" name="文本框 7">
            <a:extLst>
              <a:ext uri="{FF2B5EF4-FFF2-40B4-BE49-F238E27FC236}">
                <a16:creationId xmlns:a16="http://schemas.microsoft.com/office/drawing/2014/main" id="{8BE4B306-AD57-6868-C297-E368B978353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14206" y="4864895"/>
            <a:ext cx="1387475" cy="315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</a:endParaRP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38963" name="文本框 8">
            <a:extLst>
              <a:ext uri="{FF2B5EF4-FFF2-40B4-BE49-F238E27FC236}">
                <a16:creationId xmlns:a16="http://schemas.microsoft.com/office/drawing/2014/main" id="{00FF3A31-6990-7511-B4C1-F51FAB48904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088063" y="4841875"/>
            <a:ext cx="139065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GAMP+RU.521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TU2ZjdiN2JjZTY4ZGM3YWFmYzRjMTJiMDJlMzdkODEifQ=="/>
</p:tagLst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69</TotalTime>
  <Words>169</Words>
  <Application>Microsoft Macintosh PowerPoint</Application>
  <PresentationFormat>自定义</PresentationFormat>
  <Paragraphs>94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Times New Roman</vt:lpstr>
      <vt:lpstr>Office 2013 - 2022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cp:lastModifiedBy>18942356872@163.com</cp:lastModifiedBy>
  <cp:revision>78</cp:revision>
  <dcterms:created xsi:type="dcterms:W3CDTF">2024-12-08T09:18:18Z</dcterms:created>
  <dcterms:modified xsi:type="dcterms:W3CDTF">2025-12-20T10:12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321CCEA3293149FF97CD9B16CFEB8259_12</vt:lpwstr>
  </property>
</Properties>
</file>